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7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722" y="-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84358-847E-41AF-871B-211E647B91E0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93179C-6F48-479B-B584-6D6D5C4A33E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47987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723416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433649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192551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225913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988079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727010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83871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370753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997072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84145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86774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m 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30860" y="3802532"/>
            <a:ext cx="2561020" cy="2453028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156176" y="3789040"/>
            <a:ext cx="2572649" cy="2464166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531155" y="3802532"/>
            <a:ext cx="2553013" cy="2445356"/>
          </a:xfrm>
          <a:prstGeom prst="rect">
            <a:avLst/>
          </a:prstGeom>
        </p:spPr>
      </p:pic>
      <p:sp>
        <p:nvSpPr>
          <p:cNvPr id="19" name="CaixaDeTexto 18"/>
          <p:cNvSpPr txBox="1"/>
          <p:nvPr/>
        </p:nvSpPr>
        <p:spPr>
          <a:xfrm rot="16200000">
            <a:off x="418717" y="4753804"/>
            <a:ext cx="1268504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QUA LIVE/DEAD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ixaDeTexto 19"/>
          <p:cNvSpPr txBox="1"/>
          <p:nvPr/>
        </p:nvSpPr>
        <p:spPr>
          <a:xfrm>
            <a:off x="2067105" y="6125482"/>
            <a:ext cx="526073" cy="25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ixaDeTexto 20"/>
          <p:cNvSpPr txBox="1"/>
          <p:nvPr/>
        </p:nvSpPr>
        <p:spPr>
          <a:xfrm rot="16200000">
            <a:off x="3348776" y="4806593"/>
            <a:ext cx="518077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ixaDeTexto 21"/>
          <p:cNvSpPr txBox="1"/>
          <p:nvPr/>
        </p:nvSpPr>
        <p:spPr>
          <a:xfrm>
            <a:off x="4595421" y="6130917"/>
            <a:ext cx="593573" cy="25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 II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ixaDeTexto 22"/>
          <p:cNvSpPr txBox="1"/>
          <p:nvPr/>
        </p:nvSpPr>
        <p:spPr>
          <a:xfrm rot="16200000">
            <a:off x="6050428" y="4808683"/>
            <a:ext cx="506038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ixaDeTexto 23"/>
          <p:cNvSpPr txBox="1"/>
          <p:nvPr/>
        </p:nvSpPr>
        <p:spPr>
          <a:xfrm>
            <a:off x="7419254" y="6130917"/>
            <a:ext cx="456530" cy="25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ixaDeTexto 24"/>
          <p:cNvSpPr txBox="1"/>
          <p:nvPr/>
        </p:nvSpPr>
        <p:spPr>
          <a:xfrm>
            <a:off x="2390172" y="5723345"/>
            <a:ext cx="560847" cy="25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.3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ixaDeTexto 25"/>
          <p:cNvSpPr txBox="1"/>
          <p:nvPr/>
        </p:nvSpPr>
        <p:spPr>
          <a:xfrm>
            <a:off x="3887603" y="4203994"/>
            <a:ext cx="560847" cy="25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.08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ixaDeTexto 26"/>
          <p:cNvSpPr txBox="1"/>
          <p:nvPr/>
        </p:nvSpPr>
        <p:spPr>
          <a:xfrm>
            <a:off x="6609505" y="4085537"/>
            <a:ext cx="560847" cy="25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.35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ixaDeTexto 41"/>
          <p:cNvSpPr txBox="1"/>
          <p:nvPr/>
        </p:nvSpPr>
        <p:spPr>
          <a:xfrm>
            <a:off x="755576" y="332656"/>
            <a:ext cx="562275" cy="424233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pt-B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ixaDeTexto 42"/>
          <p:cNvSpPr txBox="1"/>
          <p:nvPr/>
        </p:nvSpPr>
        <p:spPr>
          <a:xfrm>
            <a:off x="4051579" y="260648"/>
            <a:ext cx="1425924" cy="53029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IGEMINAL 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NGLI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Grupo 47"/>
          <p:cNvGrpSpPr/>
          <p:nvPr/>
        </p:nvGrpSpPr>
        <p:grpSpPr>
          <a:xfrm>
            <a:off x="539552" y="836712"/>
            <a:ext cx="8208912" cy="3024336"/>
            <a:chOff x="755576" y="922343"/>
            <a:chExt cx="7632848" cy="2940087"/>
          </a:xfrm>
        </p:grpSpPr>
        <p:pic>
          <p:nvPicPr>
            <p:cNvPr id="32" name="Imagem 3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959791" y="922343"/>
              <a:ext cx="2428633" cy="2261280"/>
            </a:xfrm>
            <a:prstGeom prst="rect">
              <a:avLst/>
            </a:prstGeom>
          </p:spPr>
        </p:pic>
        <p:grpSp>
          <p:nvGrpSpPr>
            <p:cNvPr id="47" name="Grupo 46"/>
            <p:cNvGrpSpPr/>
            <p:nvPr/>
          </p:nvGrpSpPr>
          <p:grpSpPr>
            <a:xfrm>
              <a:off x="1125470" y="957046"/>
              <a:ext cx="6455116" cy="2317770"/>
              <a:chOff x="1125470" y="957046"/>
              <a:chExt cx="6455116" cy="2317770"/>
            </a:xfrm>
          </p:grpSpPr>
          <p:pic>
            <p:nvPicPr>
              <p:cNvPr id="30" name="Imagem 29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1125470" y="957046"/>
                <a:ext cx="2392758" cy="2227874"/>
              </a:xfrm>
              <a:prstGeom prst="rect">
                <a:avLst/>
              </a:prstGeom>
            </p:spPr>
          </p:pic>
          <p:pic>
            <p:nvPicPr>
              <p:cNvPr id="31" name="Imagem 30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524991" y="957046"/>
                <a:ext cx="2383886" cy="2219614"/>
              </a:xfrm>
              <a:prstGeom prst="rect">
                <a:avLst/>
              </a:prstGeom>
            </p:spPr>
          </p:pic>
          <p:sp>
            <p:nvSpPr>
              <p:cNvPr id="33" name="CaixaDeTexto 32"/>
              <p:cNvSpPr txBox="1"/>
              <p:nvPr/>
            </p:nvSpPr>
            <p:spPr>
              <a:xfrm rot="16200000">
                <a:off x="688586" y="1903343"/>
                <a:ext cx="1164062" cy="240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CQUA LIVE/DEAD</a:t>
                </a:r>
                <a:endParaRPr lang="pt-BR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CaixaDeTexto 33"/>
              <p:cNvSpPr txBox="1"/>
              <p:nvPr/>
            </p:nvSpPr>
            <p:spPr>
              <a:xfrm>
                <a:off x="2230644" y="3040034"/>
                <a:ext cx="496624" cy="229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  <a:endParaRPr lang="pt-BR" sz="7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CaixaDeTexto 34"/>
              <p:cNvSpPr txBox="1"/>
              <p:nvPr/>
            </p:nvSpPr>
            <p:spPr>
              <a:xfrm rot="16200000">
                <a:off x="3419776" y="1965427"/>
                <a:ext cx="475421" cy="240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  <a:endParaRPr lang="pt-BR" sz="7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CaixaDeTexto 35"/>
              <p:cNvSpPr txBox="1"/>
              <p:nvPr/>
            </p:nvSpPr>
            <p:spPr>
              <a:xfrm>
                <a:off x="4569468" y="3045023"/>
                <a:ext cx="560345" cy="229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I</a:t>
                </a:r>
                <a:endParaRPr lang="pt-BR" sz="7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CaixaDeTexto 36"/>
              <p:cNvSpPr txBox="1"/>
              <p:nvPr/>
            </p:nvSpPr>
            <p:spPr>
              <a:xfrm rot="16200000">
                <a:off x="5871170" y="1946365"/>
                <a:ext cx="464373" cy="240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OS</a:t>
                </a:r>
                <a:endParaRPr lang="pt-BR" sz="7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CaixaDeTexto 37"/>
              <p:cNvSpPr txBox="1"/>
              <p:nvPr/>
            </p:nvSpPr>
            <p:spPr>
              <a:xfrm>
                <a:off x="7149612" y="3037683"/>
                <a:ext cx="430974" cy="229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NF</a:t>
                </a:r>
                <a:endParaRPr lang="pt-BR" sz="7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CaixaDeTexto 38"/>
              <p:cNvSpPr txBox="1"/>
              <p:nvPr/>
            </p:nvSpPr>
            <p:spPr>
              <a:xfrm>
                <a:off x="2606685" y="2706435"/>
                <a:ext cx="529451" cy="229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.9%</a:t>
                </a:r>
                <a:endParaRPr lang="pt-BR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CaixaDeTexto 39"/>
              <p:cNvSpPr txBox="1"/>
              <p:nvPr/>
            </p:nvSpPr>
            <p:spPr>
              <a:xfrm>
                <a:off x="3908529" y="1323783"/>
                <a:ext cx="529451" cy="229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.58%</a:t>
                </a:r>
                <a:endParaRPr lang="pt-BR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CaixaDeTexto 40"/>
              <p:cNvSpPr txBox="1"/>
              <p:nvPr/>
            </p:nvSpPr>
            <p:spPr>
              <a:xfrm>
                <a:off x="6338007" y="1170085"/>
                <a:ext cx="529451" cy="229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.5%</a:t>
                </a:r>
                <a:endParaRPr lang="pt-BR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4" name="CaixaDeTexto 43"/>
            <p:cNvSpPr txBox="1"/>
            <p:nvPr/>
          </p:nvSpPr>
          <p:spPr>
            <a:xfrm>
              <a:off x="755576" y="3438197"/>
              <a:ext cx="562276" cy="42423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pt-B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CaixaDeTexto 44"/>
          <p:cNvSpPr txBox="1"/>
          <p:nvPr/>
        </p:nvSpPr>
        <p:spPr>
          <a:xfrm>
            <a:off x="4215258" y="3542873"/>
            <a:ext cx="963900" cy="3181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3507242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37</Words>
  <Application>Microsoft Office PowerPoint</Application>
  <PresentationFormat>Apresentação na tela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Natália</dc:creator>
  <cp:lastModifiedBy>marcoasc</cp:lastModifiedBy>
  <cp:revision>9</cp:revision>
  <dcterms:created xsi:type="dcterms:W3CDTF">2016-12-01T10:04:43Z</dcterms:created>
  <dcterms:modified xsi:type="dcterms:W3CDTF">2016-12-02T12:38:51Z</dcterms:modified>
</cp:coreProperties>
</file>